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80" d="100"/>
          <a:sy n="80" d="100"/>
        </p:scale>
        <p:origin x="312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9F0F4-9D2C-466A-A6FC-41DB884DD0C2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83EB-075E-4F59-AA82-656F0682B5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78546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9F0F4-9D2C-466A-A6FC-41DB884DD0C2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83EB-075E-4F59-AA82-656F0682B5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16338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9F0F4-9D2C-466A-A6FC-41DB884DD0C2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83EB-075E-4F59-AA82-656F0682B5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3550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9F0F4-9D2C-466A-A6FC-41DB884DD0C2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83EB-075E-4F59-AA82-656F0682B5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83711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9F0F4-9D2C-466A-A6FC-41DB884DD0C2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83EB-075E-4F59-AA82-656F0682B5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03413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9F0F4-9D2C-466A-A6FC-41DB884DD0C2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83EB-075E-4F59-AA82-656F0682B5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76033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9F0F4-9D2C-466A-A6FC-41DB884DD0C2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83EB-075E-4F59-AA82-656F0682B5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12480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9F0F4-9D2C-466A-A6FC-41DB884DD0C2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83EB-075E-4F59-AA82-656F0682B5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55734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9F0F4-9D2C-466A-A6FC-41DB884DD0C2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83EB-075E-4F59-AA82-656F0682B5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10296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9F0F4-9D2C-466A-A6FC-41DB884DD0C2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83EB-075E-4F59-AA82-656F0682B5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74014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9F0F4-9D2C-466A-A6FC-41DB884DD0C2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83EB-075E-4F59-AA82-656F0682B5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3078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D9F0F4-9D2C-466A-A6FC-41DB884DD0C2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FF83EB-075E-4F59-AA82-656F0682B5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01329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/>
          <a:srcRect l="1572" t="2435" r="419" b="262"/>
          <a:stretch/>
        </p:blipFill>
        <p:spPr>
          <a:xfrm>
            <a:off x="493434" y="478232"/>
            <a:ext cx="5540654" cy="3131242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6885" y="3780915"/>
            <a:ext cx="5708706" cy="3394475"/>
          </a:xfrm>
          <a:prstGeom prst="rect">
            <a:avLst/>
          </a:prstGeom>
        </p:spPr>
      </p:pic>
      <p:sp>
        <p:nvSpPr>
          <p:cNvPr id="6" name="Rectangle 4"/>
          <p:cNvSpPr>
            <a:spLocks noChangeArrowheads="1"/>
          </p:cNvSpPr>
          <p:nvPr/>
        </p:nvSpPr>
        <p:spPr bwMode="auto">
          <a:xfrm>
            <a:off x="493433" y="8121064"/>
            <a:ext cx="5997961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US" altLang="zh-CN" sz="1000" b="1" dirty="0" smtClean="0"/>
              <a:t>Supplementary Figure S5.</a:t>
            </a:r>
            <a:r>
              <a:rPr lang="en-US" altLang="zh-CN" sz="1000" dirty="0" smtClean="0"/>
              <a:t>  GO term enrichment analysis of down-regulated DEGs (a) and up-regulated DEGs (b) from </a:t>
            </a:r>
            <a:r>
              <a:rPr lang="en-US" altLang="zh-CN" sz="1000" i="1" dirty="0" smtClean="0"/>
              <a:t>C. </a:t>
            </a:r>
            <a:r>
              <a:rPr lang="en-US" altLang="zh-CN" sz="1000" i="1" dirty="0" err="1" smtClean="0"/>
              <a:t>meiocarpa</a:t>
            </a:r>
            <a:r>
              <a:rPr lang="en-US" altLang="zh-CN" sz="1000" i="1" dirty="0" smtClean="0"/>
              <a:t> </a:t>
            </a:r>
            <a:r>
              <a:rPr lang="en-US" altLang="zh-CN" sz="1000" i="1" dirty="0" err="1" smtClean="0"/>
              <a:t>var</a:t>
            </a:r>
            <a:r>
              <a:rPr lang="en-US" altLang="zh-CN" sz="1000" i="1" dirty="0" smtClean="0"/>
              <a:t> </a:t>
            </a:r>
            <a:r>
              <a:rPr lang="en-US" altLang="zh-CN" sz="1000" i="1" dirty="0" err="1" smtClean="0"/>
              <a:t>Hongguo</a:t>
            </a:r>
            <a:r>
              <a:rPr lang="en-US" altLang="zh-CN" sz="1000" dirty="0" smtClean="0"/>
              <a:t>.</a:t>
            </a:r>
            <a:endParaRPr lang="zh-CN" altLang="en-US" sz="1000" dirty="0"/>
          </a:p>
        </p:txBody>
      </p:sp>
      <p:sp>
        <p:nvSpPr>
          <p:cNvPr id="16" name="文本框 15"/>
          <p:cNvSpPr txBox="1"/>
          <p:nvPr/>
        </p:nvSpPr>
        <p:spPr>
          <a:xfrm>
            <a:off x="161415" y="300536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164423" y="3595443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93378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3</TotalTime>
  <Words>33</Words>
  <Application>Microsoft Office PowerPoint</Application>
  <PresentationFormat>A4 纸张(210x297 毫米)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SimSun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user</dc:creator>
  <cp:lastModifiedBy>user</cp:lastModifiedBy>
  <cp:revision>14</cp:revision>
  <dcterms:created xsi:type="dcterms:W3CDTF">2023-06-22T03:22:28Z</dcterms:created>
  <dcterms:modified xsi:type="dcterms:W3CDTF">2023-06-27T07:32:08Z</dcterms:modified>
</cp:coreProperties>
</file>